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8" d="100"/>
          <a:sy n="88" d="100"/>
        </p:scale>
        <p:origin x="-1376" y="-10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772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1995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7802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687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066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5307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054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038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9880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4180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403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47A30-3EFD-8E40-B5EA-97A5F37C52DF}" type="datetimeFigureOut">
              <a:rPr lang="en-US" smtClean="0"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DB9B3-B0A2-B94B-8223-3FAA20417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3499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9" Type="http://schemas.openxmlformats.org/officeDocument/2006/relationships/image" Target="../media/image8.tiff"/><Relationship Id="rId10" Type="http://schemas.openxmlformats.org/officeDocument/2006/relationships/image" Target="../media/image9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roup 87"/>
          <p:cNvGrpSpPr/>
          <p:nvPr/>
        </p:nvGrpSpPr>
        <p:grpSpPr>
          <a:xfrm>
            <a:off x="866257" y="1151951"/>
            <a:ext cx="7498067" cy="4849890"/>
            <a:chOff x="866257" y="1151951"/>
            <a:chExt cx="7498067" cy="4849890"/>
          </a:xfrm>
        </p:grpSpPr>
        <p:cxnSp>
          <p:nvCxnSpPr>
            <p:cNvPr id="4" name="Straight Connector 3"/>
            <p:cNvCxnSpPr/>
            <p:nvPr/>
          </p:nvCxnSpPr>
          <p:spPr>
            <a:xfrm>
              <a:off x="1164214" y="583599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866948" y="5707967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2</a:t>
              </a:r>
              <a:r>
                <a:rPr lang="en-GB" sz="1000" dirty="0" smtClean="0"/>
                <a:t>00</a:t>
              </a:r>
              <a:endParaRPr lang="en-GB" sz="1000" dirty="0"/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1164214" y="5634040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866948" y="5506010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3</a:t>
              </a:r>
              <a:r>
                <a:rPr lang="en-GB" sz="1000" dirty="0" smtClean="0"/>
                <a:t>00</a:t>
              </a:r>
              <a:endParaRPr lang="en-GB" sz="1000" dirty="0"/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1163524" y="530139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866257" y="5173367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1163524" y="5099440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866257" y="4971407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1163524" y="4920740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866257" y="4792710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300</a:t>
              </a:r>
              <a:endParaRPr lang="en-GB" sz="1000" dirty="0"/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1164214" y="4534948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866948" y="440691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1164214" y="4332991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866948" y="4204959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1164214" y="3916155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866948" y="378812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1164214" y="3714196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866948" y="358616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1164214" y="3535496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866948" y="340746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300</a:t>
              </a:r>
              <a:endParaRPr lang="en-GB" sz="1000" dirty="0"/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4908631" y="5327036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4611364" y="519900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26" name="Straight Connector 25"/>
            <p:cNvCxnSpPr/>
            <p:nvPr/>
          </p:nvCxnSpPr>
          <p:spPr>
            <a:xfrm>
              <a:off x="4908631" y="512507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4611364" y="4997047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28" name="Straight Connector 27"/>
            <p:cNvCxnSpPr/>
            <p:nvPr/>
          </p:nvCxnSpPr>
          <p:spPr>
            <a:xfrm>
              <a:off x="4908631" y="4929287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611364" y="4801255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300</a:t>
              </a:r>
              <a:endParaRPr lang="en-GB" sz="1000" dirty="0"/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4908631" y="4534948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4611364" y="440691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4908631" y="4365295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4611364" y="423726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4908631" y="4229324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4611364" y="4101294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300</a:t>
              </a:r>
              <a:endParaRPr lang="en-GB" sz="1000" dirty="0"/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4907941" y="3988967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4610673" y="3860937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4907941" y="378700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4610673" y="365897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4907941" y="3608309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4610673" y="348027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300</a:t>
              </a:r>
              <a:endParaRPr lang="en-GB" sz="1000" dirty="0"/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4907941" y="3263981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4610673" y="3135950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4907941" y="3062023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4610673" y="293399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46" name="Straight Connector 45"/>
            <p:cNvCxnSpPr/>
            <p:nvPr/>
          </p:nvCxnSpPr>
          <p:spPr>
            <a:xfrm>
              <a:off x="4907941" y="2866231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4610673" y="2738201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300</a:t>
              </a:r>
              <a:endParaRPr lang="en-GB" sz="1000" dirty="0"/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1163524" y="3221712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866257" y="3093682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100</a:t>
              </a:r>
              <a:endParaRPr lang="en-GB" sz="1000" dirty="0"/>
            </a:p>
          </p:txBody>
        </p:sp>
        <p:cxnSp>
          <p:nvCxnSpPr>
            <p:cNvPr id="50" name="Straight Connector 49"/>
            <p:cNvCxnSpPr/>
            <p:nvPr/>
          </p:nvCxnSpPr>
          <p:spPr>
            <a:xfrm>
              <a:off x="1163524" y="3019755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866257" y="289172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200</a:t>
              </a:r>
              <a:endParaRPr lang="en-GB" sz="1000" dirty="0"/>
            </a:p>
          </p:txBody>
        </p:sp>
        <p:cxnSp>
          <p:nvCxnSpPr>
            <p:cNvPr id="52" name="Straight Connector 51"/>
            <p:cNvCxnSpPr/>
            <p:nvPr/>
          </p:nvCxnSpPr>
          <p:spPr>
            <a:xfrm>
              <a:off x="1163524" y="2849600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866257" y="272156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300</a:t>
              </a:r>
              <a:endParaRPr lang="en-GB" sz="1000" dirty="0"/>
            </a:p>
          </p:txBody>
        </p:sp>
        <p:pic>
          <p:nvPicPr>
            <p:cNvPr id="54" name="Content Placeholder 3" descr="ms non de qpcr 4 3224.tif"/>
            <p:cNvPicPr>
              <a:picLocks noChangeAspect="1"/>
            </p:cNvPicPr>
            <p:nvPr/>
          </p:nvPicPr>
          <p:blipFill>
            <a:blip r:embed="rId2" cstate="print">
              <a:lum bright="20000" contrast="47000"/>
            </a:blip>
            <a:srcRect l="2667" t="54889" b="30792"/>
            <a:stretch>
              <a:fillRect/>
            </a:stretch>
          </p:blipFill>
          <p:spPr>
            <a:xfrm>
              <a:off x="1235534" y="2762599"/>
              <a:ext cx="3384376" cy="5564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5" name="Picture 54" descr="ms non de qpcr peak 26.tif"/>
            <p:cNvPicPr>
              <a:picLocks noChangeAspect="1"/>
            </p:cNvPicPr>
            <p:nvPr/>
          </p:nvPicPr>
          <p:blipFill rotWithShape="1">
            <a:blip r:embed="rId3" cstate="print">
              <a:lum bright="10000" contrast="52000"/>
            </a:blip>
            <a:srcRect t="61111" r="3190" b="25000"/>
            <a:stretch/>
          </p:blipFill>
          <p:spPr>
            <a:xfrm>
              <a:off x="4980324" y="3521952"/>
              <a:ext cx="3384000" cy="544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6" name="Content Placeholder 3" descr="ms non de qpcr 2 peak 13.tif"/>
            <p:cNvPicPr>
              <a:picLocks noChangeAspect="1"/>
            </p:cNvPicPr>
            <p:nvPr/>
          </p:nvPicPr>
          <p:blipFill rotWithShape="1">
            <a:blip r:embed="rId4" cstate="print">
              <a:lum bright="14000" contrast="38000"/>
            </a:blip>
            <a:srcRect l="5918" t="54698" r="1991" b="31811"/>
            <a:stretch/>
          </p:blipFill>
          <p:spPr>
            <a:xfrm>
              <a:off x="4980324" y="2762589"/>
              <a:ext cx="3384000" cy="5748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7" name="Picture 56" descr="ms non de qpcr 5 peak 14.tif"/>
            <p:cNvPicPr>
              <a:picLocks noChangeAspect="1"/>
            </p:cNvPicPr>
            <p:nvPr/>
          </p:nvPicPr>
          <p:blipFill rotWithShape="1">
            <a:blip r:embed="rId5" cstate="print">
              <a:lum bright="20000" contrast="48000"/>
            </a:blip>
            <a:srcRect l="1994" t="64369" r="4687" b="24641"/>
            <a:stretch/>
          </p:blipFill>
          <p:spPr>
            <a:xfrm>
              <a:off x="1235533" y="3521954"/>
              <a:ext cx="3384000" cy="3966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8" name="Picture 57" descr="pcr non de peak 32.tif"/>
            <p:cNvPicPr>
              <a:picLocks noChangeAspect="1"/>
            </p:cNvPicPr>
            <p:nvPr/>
          </p:nvPicPr>
          <p:blipFill>
            <a:blip r:embed="rId6" cstate="print"/>
            <a:srcRect t="51545" b="34710"/>
            <a:stretch>
              <a:fillRect/>
            </a:stretch>
          </p:blipFill>
          <p:spPr>
            <a:xfrm>
              <a:off x="1235533" y="4211744"/>
              <a:ext cx="3384000" cy="5194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9" name="Content Placeholder 3" descr="ms non de peak 40.tif"/>
            <p:cNvPicPr>
              <a:picLocks noChangeAspect="1"/>
            </p:cNvPicPr>
            <p:nvPr/>
          </p:nvPicPr>
          <p:blipFill>
            <a:blip r:embed="rId7" cstate="print">
              <a:lum bright="23000" contrast="50000"/>
            </a:blip>
            <a:srcRect t="61384" b="22462"/>
            <a:stretch>
              <a:fillRect/>
            </a:stretch>
          </p:blipFill>
          <p:spPr>
            <a:xfrm>
              <a:off x="1235533" y="4883803"/>
              <a:ext cx="3384000" cy="4350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0" name="Content Placeholder 3" descr="ms non de qpcr 3 peak 49.tif"/>
            <p:cNvPicPr>
              <a:picLocks noChangeAspect="1"/>
            </p:cNvPicPr>
            <p:nvPr/>
          </p:nvPicPr>
          <p:blipFill rotWithShape="1">
            <a:blip r:embed="rId8" cstate="print">
              <a:lum contrast="32000"/>
            </a:blip>
            <a:srcRect t="47092" b="42073"/>
            <a:stretch/>
          </p:blipFill>
          <p:spPr>
            <a:xfrm>
              <a:off x="1235533" y="5523276"/>
              <a:ext cx="3384000" cy="4785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Content Placeholder 3" descr="ms non de qpcr peak 39.tif"/>
            <p:cNvPicPr>
              <a:picLocks noChangeAspect="1"/>
            </p:cNvPicPr>
            <p:nvPr/>
          </p:nvPicPr>
          <p:blipFill rotWithShape="1">
            <a:blip r:embed="rId9" cstate="print">
              <a:lum bright="21000" contrast="45000"/>
            </a:blip>
            <a:srcRect l="3022" t="53194" r="5263" b="37134"/>
            <a:stretch/>
          </p:blipFill>
          <p:spPr>
            <a:xfrm>
              <a:off x="4980324" y="4211744"/>
              <a:ext cx="3384000" cy="4112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2" name="Content Placeholder 3" descr="ms non de qpcr 2 peak 44.tif"/>
            <p:cNvPicPr>
              <a:picLocks noChangeAspect="1"/>
            </p:cNvPicPr>
            <p:nvPr/>
          </p:nvPicPr>
          <p:blipFill rotWithShape="1">
            <a:blip r:embed="rId10" cstate="print">
              <a:lum bright="18000" contrast="37000"/>
            </a:blip>
            <a:srcRect l="4322" t="55644" r="6290" b="32476"/>
            <a:stretch/>
          </p:blipFill>
          <p:spPr>
            <a:xfrm>
              <a:off x="4980323" y="4883803"/>
              <a:ext cx="3384000" cy="4783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3" name="TextBox 62"/>
            <p:cNvSpPr txBox="1"/>
            <p:nvPr/>
          </p:nvSpPr>
          <p:spPr>
            <a:xfrm rot="16200000">
              <a:off x="1466657" y="1858202"/>
              <a:ext cx="1656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Excess </a:t>
              </a:r>
              <a:r>
                <a:rPr lang="en-GB" sz="1000" dirty="0"/>
                <a:t>n</a:t>
              </a:r>
              <a:r>
                <a:rPr lang="en-GB" sz="1000" dirty="0" smtClean="0"/>
                <a:t>o antibody control</a:t>
              </a:r>
              <a:endParaRPr lang="en-GB" sz="1000" dirty="0"/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1083526" y="1925592"/>
              <a:ext cx="15583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err="1" smtClean="0"/>
                <a:t>ChIP</a:t>
              </a:r>
              <a:r>
                <a:rPr lang="en-GB" sz="1000" dirty="0"/>
                <a:t> </a:t>
              </a:r>
              <a:r>
                <a:rPr lang="en-GB" sz="1000" dirty="0" smtClean="0"/>
                <a:t>nitrogen excess </a:t>
              </a:r>
              <a:endParaRPr lang="en-GB" sz="1000" dirty="0"/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3668705" y="2092696"/>
              <a:ext cx="12241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No DNA control</a:t>
              </a:r>
              <a:endParaRPr lang="en-GB" sz="1000" dirty="0"/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2627080" y="1894204"/>
              <a:ext cx="1639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Input nitrogen excess</a:t>
              </a:r>
              <a:endParaRPr lang="en-GB" sz="1000" dirty="0"/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3006779" y="1872055"/>
              <a:ext cx="16838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Input nitrogen limiting</a:t>
              </a:r>
              <a:endParaRPr lang="en-GB" sz="1000" dirty="0"/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2198349" y="1858202"/>
              <a:ext cx="1656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Limiting </a:t>
              </a:r>
              <a:r>
                <a:rPr lang="en-GB" sz="1000" dirty="0"/>
                <a:t>n</a:t>
              </a:r>
              <a:r>
                <a:rPr lang="en-GB" sz="1000" dirty="0" smtClean="0"/>
                <a:t>o antibody control</a:t>
              </a:r>
              <a:endParaRPr lang="en-GB" sz="1000" dirty="0"/>
            </a:p>
          </p:txBody>
        </p:sp>
        <p:sp>
          <p:nvSpPr>
            <p:cNvPr id="69" name="TextBox 68"/>
            <p:cNvSpPr txBox="1"/>
            <p:nvPr/>
          </p:nvSpPr>
          <p:spPr>
            <a:xfrm rot="16200000">
              <a:off x="1840836" y="1889588"/>
              <a:ext cx="1630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err="1" smtClean="0"/>
                <a:t>ChIP</a:t>
              </a:r>
              <a:r>
                <a:rPr lang="en-GB" sz="1000" dirty="0" smtClean="0"/>
                <a:t> nitrogen limiting </a:t>
              </a:r>
              <a:endParaRPr lang="en-GB" sz="1000" dirty="0"/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5215979" y="1856936"/>
              <a:ext cx="1656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Excess </a:t>
              </a:r>
              <a:r>
                <a:rPr lang="en-GB" sz="1000" dirty="0"/>
                <a:t>n</a:t>
              </a:r>
              <a:r>
                <a:rPr lang="en-GB" sz="1000" dirty="0" smtClean="0"/>
                <a:t>o antibody control</a:t>
              </a:r>
              <a:endParaRPr lang="en-GB" sz="1000" dirty="0"/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4832848" y="1924326"/>
              <a:ext cx="15583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err="1" smtClean="0"/>
                <a:t>ChIP</a:t>
              </a:r>
              <a:r>
                <a:rPr lang="en-GB" sz="1000" dirty="0"/>
                <a:t> </a:t>
              </a:r>
              <a:r>
                <a:rPr lang="en-GB" sz="1000" dirty="0" smtClean="0"/>
                <a:t>nitrogen excess </a:t>
              </a:r>
              <a:endParaRPr lang="en-GB" sz="1000" dirty="0"/>
            </a:p>
          </p:txBody>
        </p:sp>
        <p:sp>
          <p:nvSpPr>
            <p:cNvPr id="72" name="TextBox 71"/>
            <p:cNvSpPr txBox="1"/>
            <p:nvPr/>
          </p:nvSpPr>
          <p:spPr>
            <a:xfrm rot="16200000">
              <a:off x="7418027" y="2091431"/>
              <a:ext cx="12241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No DNA control</a:t>
              </a:r>
              <a:endParaRPr lang="en-GB" sz="1000" dirty="0"/>
            </a:p>
          </p:txBody>
        </p:sp>
        <p:sp>
          <p:nvSpPr>
            <p:cNvPr id="73" name="TextBox 72"/>
            <p:cNvSpPr txBox="1"/>
            <p:nvPr/>
          </p:nvSpPr>
          <p:spPr>
            <a:xfrm rot="16200000">
              <a:off x="6376402" y="1892939"/>
              <a:ext cx="1639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Input nitrogen excess</a:t>
              </a:r>
              <a:endParaRPr lang="en-GB" sz="1000" dirty="0"/>
            </a:p>
          </p:txBody>
        </p:sp>
        <p:sp>
          <p:nvSpPr>
            <p:cNvPr id="74" name="TextBox 73"/>
            <p:cNvSpPr txBox="1"/>
            <p:nvPr/>
          </p:nvSpPr>
          <p:spPr>
            <a:xfrm rot="16200000">
              <a:off x="6756101" y="1870788"/>
              <a:ext cx="16838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Input nitrogen limiting</a:t>
              </a:r>
              <a:endParaRPr lang="en-GB" sz="1000" dirty="0"/>
            </a:p>
          </p:txBody>
        </p:sp>
        <p:sp>
          <p:nvSpPr>
            <p:cNvPr id="75" name="TextBox 74"/>
            <p:cNvSpPr txBox="1"/>
            <p:nvPr/>
          </p:nvSpPr>
          <p:spPr>
            <a:xfrm rot="16200000">
              <a:off x="5947671" y="1856936"/>
              <a:ext cx="1656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Limiting </a:t>
              </a:r>
              <a:r>
                <a:rPr lang="en-GB" sz="1000" dirty="0"/>
                <a:t>n</a:t>
              </a:r>
              <a:r>
                <a:rPr lang="en-GB" sz="1000" dirty="0" smtClean="0"/>
                <a:t>o antibody control</a:t>
              </a:r>
              <a:endParaRPr lang="en-GB" sz="1000" dirty="0"/>
            </a:p>
          </p:txBody>
        </p:sp>
        <p:sp>
          <p:nvSpPr>
            <p:cNvPr id="76" name="TextBox 75"/>
            <p:cNvSpPr txBox="1"/>
            <p:nvPr/>
          </p:nvSpPr>
          <p:spPr>
            <a:xfrm rot="16200000">
              <a:off x="5590158" y="1888322"/>
              <a:ext cx="1630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err="1" smtClean="0"/>
                <a:t>ChIP</a:t>
              </a:r>
              <a:r>
                <a:rPr lang="en-GB" sz="1000" dirty="0" smtClean="0"/>
                <a:t> nitrogen limiting </a:t>
              </a:r>
              <a:endParaRPr lang="en-GB" sz="10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172071" y="2540851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A.</a:t>
              </a:r>
              <a:endParaRPr lang="en-GB" sz="1000" b="1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899448" y="2547153"/>
              <a:ext cx="3189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err="1" smtClean="0"/>
                <a:t>bp</a:t>
              </a:r>
              <a:endParaRPr lang="en-GB" sz="800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631759" y="2544172"/>
              <a:ext cx="3189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err="1" smtClean="0"/>
                <a:t>bp</a:t>
              </a:r>
              <a:endParaRPr lang="en-GB" sz="800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911245" y="2540851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B.</a:t>
              </a:r>
              <a:endParaRPr lang="en-GB" sz="1000" b="1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172071" y="3319506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C.</a:t>
              </a:r>
              <a:endParaRPr lang="en-GB" sz="1000" b="1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911245" y="3319506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D.</a:t>
              </a:r>
              <a:endParaRPr lang="en-GB" sz="1000" b="1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172071" y="4029074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E.</a:t>
              </a:r>
              <a:endParaRPr lang="en-GB" sz="1000" b="1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911245" y="4029074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F.</a:t>
              </a:r>
              <a:endParaRPr lang="en-GB" sz="1000" b="1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172071" y="4694950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G.</a:t>
              </a:r>
              <a:endParaRPr lang="en-GB" sz="1000" b="1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4911245" y="4694950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H.</a:t>
              </a:r>
              <a:endParaRPr lang="en-GB" sz="1000" b="1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172071" y="5339578"/>
              <a:ext cx="318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I.</a:t>
              </a:r>
              <a:endParaRPr lang="en-GB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560920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Macintosh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Robertson</dc:creator>
  <cp:lastModifiedBy>Brian Robertson</cp:lastModifiedBy>
  <cp:revision>1</cp:revision>
  <dcterms:created xsi:type="dcterms:W3CDTF">2013-02-27T17:02:31Z</dcterms:created>
  <dcterms:modified xsi:type="dcterms:W3CDTF">2013-02-27T17:17:49Z</dcterms:modified>
</cp:coreProperties>
</file>